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4"/>
  </p:sldMasterIdLst>
  <p:sldIdLst>
    <p:sldId id="256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9B882"/>
    <a:srgbClr val="354F5F"/>
    <a:srgbClr val="485063"/>
    <a:srgbClr val="343D52"/>
    <a:srgbClr val="152538"/>
    <a:srgbClr val="0C2D4C"/>
    <a:srgbClr val="2D3E55"/>
    <a:srgbClr val="011893"/>
    <a:srgbClr val="005493"/>
    <a:srgbClr val="0048A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858"/>
    <p:restoredTop sz="94718"/>
  </p:normalViewPr>
  <p:slideViewPr>
    <p:cSldViewPr snapToGrid="0" snapToObjects="1">
      <p:cViewPr varScale="1">
        <p:scale>
          <a:sx n="68" d="100"/>
          <a:sy n="68" d="100"/>
        </p:scale>
        <p:origin x="118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5" Type="http://schemas.openxmlformats.org/officeDocument/2006/relationships/slide" Target="slides/slide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B0934A-73F7-1F4D-8E48-3E4A6021BAA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F5CDD2B-C91F-C94C-859A-713BFC4DD1C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91ED89-A522-574C-BEF6-23952F3B4B57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2/14/2022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6863A7-7AEA-9B47-919A-F8290FDF75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907878-B1BF-934B-B3EE-C0F2BF7722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439624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16CE03-BAB6-DF4C-8DDE-EDF8B40D5F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1739278-2F15-C545-AAAE-F43E2A6854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2E6775-CD32-3142-8FBA-CDFB263F3F21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2/14/2022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61732B-9114-794D-A840-56608EFFA3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87E824-670B-F54F-B320-0C9D58D344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300066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A98D59E-1E91-6442-B486-69DCB6DED4B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  <a:prstGeom prst="rect">
            <a:avLst/>
          </a:prstGeo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9C48020-99DE-034A-896B-B168AFB2382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B4BD8C-E04E-344D-BCA3-4A12AF9F9FD1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2/14/2022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22BA77-B54E-294B-8E51-618E052661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87FCA8-BA90-3541-B0B2-65F59CAACB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355438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11FE32-5B64-E243-9843-A1EA2051C3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E68202A-F2E5-FC45-ACF7-E80F6D7F883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4E0E2A-40A9-9E49-9929-3C392D318731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2/14/2022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FC6A75-50A7-FD48-9F8D-FB2C39DA3A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3C649F-74CE-F84F-B801-BA6564F4E0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68931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C92EFB-E534-0B42-82B0-D66CA3A688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4ED4610-C5DA-DD4F-87FA-011B5B738A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9B7977-8B5A-5F4D-A953-66956B975D5E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2/14/2022</a:t>
            </a:fld>
            <a:endParaRPr lang="en-US" dirty="0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9D024F-74DA-F747-9F3F-12FC385748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 dirty="0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B084D1-6F99-7B4A-86C4-626B3DBD42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499647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EB8CA2-0484-E046-B109-39812C272F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398EB0-FE7C-194F-ADF9-152ECCB3958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3031F7A-AE90-1B46-AE9B-15C84FAB353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81FA71C-8983-674C-A8D8-7A92D4E77443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2/14/2022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3CCBC2C-F5E8-8B44-AAF8-57C9F683BE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C138B94-9D6F-7649-A1CE-5DF2873EAA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684855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D4A7FB-656F-2D44-BF6D-9A6296F5C5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5ED082F-CF7B-6640-B0DD-47812C442D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97A971E-FD89-D045-859D-668111E877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97CA272-0B40-1C4C-8651-B6B649E82CA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BA28564-A83D-3D41-9326-EE04008E1CA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26F9878-94A7-D440-9A77-51A1EA8F785D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2/14/2022</a:t>
            </a:fld>
            <a:endParaRPr lang="en-US" dirty="0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13572D8-65D0-A74D-9157-DA78839BAC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 dirty="0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367A03D-FD78-174E-A057-4CDF5DE3C8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4355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B3D4D0-427F-3644-AE9F-7F9F02C8FE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A6876D9-D8F4-3E46-AD79-3F1CA5075968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2/14/2022</a:t>
            </a:fld>
            <a:endParaRPr lang="en-US" dirty="0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4D88B33-B404-7D49-8C6E-72E7BEE548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 dirty="0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4BF84DA-594E-BF46-A0F9-E98ECA299D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842033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C642915-FDC1-FB40-B2EA-C81621B13A4E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2/14/2022</a:t>
            </a:fld>
            <a:endParaRPr lang="en-US" dirty="0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1282C27-207A-D143-B2F5-5ACDD3A0A9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363BDB4-97C0-664F-82A9-FDEED8DC8B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460744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B6FD49-22F7-6342-8EB6-58DC854D98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E738B74-02DD-4E41-B862-2E393D02CCF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763CE6A-13AB-674E-94BC-02C05CBD269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DD367F2-1863-8745-B0C0-223C48254926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2/14/2022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2BA1F2-4205-3B42-9CA2-608CF7CB1D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4671325-42DD-9D4C-BA1C-C3F3E0481E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399702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737B78-070F-F345-B4F5-2CD85DB00F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73A062D-BBBC-9E4F-BB12-301E15D789C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5B13057-E866-B245-8719-C8F338C3C08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ED9CA1E-011F-874B-B115-68686FE8F4EC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2/14/2022</a:t>
            </a:fld>
            <a:endParaRPr lang="en-US" dirty="0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F22A0C4-99AA-1345-9159-65D57E98C6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817377B-6239-5143-A68F-90A23176B5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258952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5">
            <a:lumMod val="20000"/>
            <a:lumOff val="8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8440401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2.png"/><Relationship Id="rId7" Type="http://schemas.microsoft.com/office/2007/relationships/hdphoto" Target="../media/hdphoto1.wdp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Picture 15">
            <a:extLst>
              <a:ext uri="{FF2B5EF4-FFF2-40B4-BE49-F238E27FC236}">
                <a16:creationId xmlns:a16="http://schemas.microsoft.com/office/drawing/2014/main" id="{F0DEE156-89C7-FF43-991B-3DD24BD32DD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-25894"/>
            <a:ext cx="12192000" cy="707886"/>
          </a:xfrm>
          <a:prstGeom prst="rect">
            <a:avLst/>
          </a:prstGeom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F548E9D6-92B2-D44D-BBCE-51953A30C681}"/>
              </a:ext>
            </a:extLst>
          </p:cNvPr>
          <p:cNvSpPr/>
          <p:nvPr/>
        </p:nvSpPr>
        <p:spPr>
          <a:xfrm>
            <a:off x="0" y="683179"/>
            <a:ext cx="12192000" cy="231227"/>
          </a:xfrm>
          <a:prstGeom prst="rect">
            <a:avLst/>
          </a:prstGeom>
          <a:solidFill>
            <a:srgbClr val="343D52"/>
          </a:solidFill>
          <a:ln>
            <a:solidFill>
              <a:srgbClr val="354F5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200" dirty="0">
                <a:solidFill>
                  <a:schemeClr val="bg1"/>
                </a:solidFill>
              </a:rPr>
              <a:t>           @</a:t>
            </a:r>
            <a:r>
              <a:rPr lang="en-US" sz="1200" dirty="0" err="1">
                <a:solidFill>
                  <a:schemeClr val="bg1"/>
                </a:solidFill>
              </a:rPr>
              <a:t>TheTxIDJournal</a:t>
            </a:r>
            <a:r>
              <a:rPr lang="en-US" sz="1200" dirty="0">
                <a:solidFill>
                  <a:schemeClr val="bg1"/>
                </a:solidFill>
              </a:rPr>
              <a:t>  @</a:t>
            </a:r>
            <a:r>
              <a:rPr lang="en-US" sz="1200" dirty="0" err="1">
                <a:solidFill>
                  <a:schemeClr val="bg1"/>
                </a:solidFill>
              </a:rPr>
              <a:t>MichaelGIsonMD</a:t>
            </a:r>
            <a:endParaRPr lang="en-US" sz="1200" dirty="0">
              <a:solidFill>
                <a:schemeClr val="bg1"/>
              </a:solidFill>
            </a:endParaRP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23CCF476-319F-8140-A593-7D3D0C061C4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4854" y="668975"/>
            <a:ext cx="276606" cy="276606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492131EC-6391-3144-8E00-5CE130B4CE5F}"/>
              </a:ext>
            </a:extLst>
          </p:cNvPr>
          <p:cNvSpPr txBox="1"/>
          <p:nvPr/>
        </p:nvSpPr>
        <p:spPr>
          <a:xfrm>
            <a:off x="8616989" y="660292"/>
            <a:ext cx="3257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err="1">
                <a:solidFill>
                  <a:schemeClr val="bg1"/>
                </a:solidFill>
              </a:rPr>
              <a:t>Ison</a:t>
            </a:r>
            <a:r>
              <a:rPr lang="en-US" sz="1200">
                <a:solidFill>
                  <a:schemeClr val="bg1"/>
                </a:solidFill>
              </a:rPr>
              <a:t> </a:t>
            </a:r>
            <a:r>
              <a:rPr lang="en-US" sz="1200" i="1">
                <a:solidFill>
                  <a:schemeClr val="bg1"/>
                </a:solidFill>
              </a:rPr>
              <a:t>et al</a:t>
            </a:r>
            <a:r>
              <a:rPr lang="en-US" sz="1200">
                <a:solidFill>
                  <a:schemeClr val="bg1"/>
                </a:solidFill>
              </a:rPr>
              <a:t>.  </a:t>
            </a:r>
            <a:r>
              <a:rPr lang="en-US" sz="1200" b="1" i="1">
                <a:solidFill>
                  <a:schemeClr val="bg1"/>
                </a:solidFill>
              </a:rPr>
              <a:t>Transplant Infectious Diseases</a:t>
            </a:r>
            <a:r>
              <a:rPr lang="en-US" sz="1200">
                <a:solidFill>
                  <a:schemeClr val="bg1"/>
                </a:solidFill>
              </a:rPr>
              <a:t>.  2022.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F1A0D7E5-0BBB-AD44-B806-57C0B508F8D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6073352"/>
            <a:ext cx="12271830" cy="93620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97FD39CF-48BE-F043-9CA6-1EA6F45D25E8}"/>
              </a:ext>
            </a:extLst>
          </p:cNvPr>
          <p:cNvSpPr txBox="1"/>
          <p:nvPr/>
        </p:nvSpPr>
        <p:spPr>
          <a:xfrm>
            <a:off x="126124" y="3"/>
            <a:ext cx="1192347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800" b="1">
                <a:solidFill>
                  <a:schemeClr val="bg1"/>
                </a:solidFill>
              </a:rPr>
              <a:t>Quantitative Norovirus Viral Load Is Not Affected by Home Storage of Stool</a:t>
            </a:r>
            <a:endParaRPr lang="en-US" sz="2800">
              <a:solidFill>
                <a:schemeClr val="bg1"/>
              </a:solidFill>
            </a:endParaRPr>
          </a:p>
        </p:txBody>
      </p: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366636D0-BF84-4A1A-9E37-3446B179CF50}"/>
              </a:ext>
            </a:extLst>
          </p:cNvPr>
          <p:cNvCxnSpPr/>
          <p:nvPr/>
        </p:nvCxnSpPr>
        <p:spPr>
          <a:xfrm>
            <a:off x="0" y="639744"/>
            <a:ext cx="12192000" cy="0"/>
          </a:xfrm>
          <a:prstGeom prst="line">
            <a:avLst/>
          </a:prstGeom>
          <a:ln w="76200">
            <a:solidFill>
              <a:srgbClr val="39B88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" name="Picture 3">
            <a:extLst>
              <a:ext uri="{FF2B5EF4-FFF2-40B4-BE49-F238E27FC236}">
                <a16:creationId xmlns:a16="http://schemas.microsoft.com/office/drawing/2014/main" id="{519F6E7C-7413-FC42-B3A4-D3DAF86884D2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alphaModFix amt="52000"/>
          </a:blip>
          <a:srcRect l="13820" t="2225" r="13614" b="1396"/>
          <a:stretch/>
        </p:blipFill>
        <p:spPr>
          <a:xfrm>
            <a:off x="-1" y="1072347"/>
            <a:ext cx="1726469" cy="1718559"/>
          </a:xfrm>
          <a:prstGeom prst="rect">
            <a:avLst/>
          </a:prstGeom>
          <a:solidFill>
            <a:schemeClr val="accent1">
              <a:lumMod val="40000"/>
              <a:lumOff val="60000"/>
            </a:schemeClr>
          </a:solidFill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FAFBE7C0-702D-0A4A-9FF9-6A75F66161BD}"/>
              </a:ext>
            </a:extLst>
          </p:cNvPr>
          <p:cNvSpPr txBox="1"/>
          <p:nvPr/>
        </p:nvSpPr>
        <p:spPr>
          <a:xfrm>
            <a:off x="1759127" y="966521"/>
            <a:ext cx="6045930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 err="1"/>
              <a:t>Nororvirus</a:t>
            </a:r>
            <a:r>
              <a:rPr lang="en-US" sz="1400" dirty="0"/>
              <a:t> is small, non-enveloped, single-stranded RNA viru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/>
              <a:t>Leading infectious cause of diarrhea that results in prolonged shedding and relapsing symptoms that lasts months to years in immunocompromised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/>
              <a:t>Studies require numerous clinic visits to drop of fresh stool for required studie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82A715E-03F6-5C45-BEAA-09579BA74C23}"/>
              </a:ext>
            </a:extLst>
          </p:cNvPr>
          <p:cNvSpPr txBox="1"/>
          <p:nvPr/>
        </p:nvSpPr>
        <p:spPr>
          <a:xfrm>
            <a:off x="1835178" y="2131840"/>
            <a:ext cx="5969877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tudy Questions</a:t>
            </a:r>
            <a:r>
              <a:rPr lang="en-US" sz="1600" dirty="0"/>
              <a:t>:  Can patients collect and store stool at home and bring to clinic at less frequent intervals?  Will storage in frost-free freezers affect the ability to detect and quantitate virus load?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AED9E200-C624-F746-9FDE-2B1C14177BC8}"/>
              </a:ext>
            </a:extLst>
          </p:cNvPr>
          <p:cNvSpPr txBox="1"/>
          <p:nvPr/>
        </p:nvSpPr>
        <p:spPr>
          <a:xfrm>
            <a:off x="150639" y="3012062"/>
            <a:ext cx="7654415" cy="21852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Methods: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600" dirty="0"/>
              <a:t>Part of the Nitazoxanide for Norovirus in Transplant Study (NNITS, NCT03395405) funded by NIAID (HHSN273301600016C )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600" dirty="0"/>
              <a:t>Fresh stool was collected from subjects in clinic and aliquoted:</a:t>
            </a:r>
          </a:p>
          <a:p>
            <a:pPr lvl="1"/>
            <a:r>
              <a:rPr lang="en-US" sz="1400" dirty="0"/>
              <a:t>💩 Processed and stored at -80°C per current SOP</a:t>
            </a:r>
          </a:p>
          <a:p>
            <a:pPr lvl="1"/>
            <a:r>
              <a:rPr lang="en-US" sz="1400" dirty="0"/>
              <a:t>💩 Stored in a collection tub at -20° in frost-free freezer for 2 weeks</a:t>
            </a:r>
          </a:p>
          <a:p>
            <a:pPr lvl="1"/>
            <a:r>
              <a:rPr lang="en-US" sz="1400" dirty="0"/>
              <a:t>💩 Stored in a collection tub at -20° in frost-free freezer for 2 months</a:t>
            </a:r>
          </a:p>
          <a:p>
            <a:pPr lvl="1"/>
            <a:r>
              <a:rPr lang="en-US" sz="1400" dirty="0"/>
              <a:t>💩 All frost-free samples were thawed and aliquoted and placed at -80° for shipment to central lab for testing in blinded fashion</a:t>
            </a:r>
          </a:p>
        </p:txBody>
      </p:sp>
      <p:pic>
        <p:nvPicPr>
          <p:cNvPr id="10" name="Picture 9" descr="Table&#10;&#10;Description automatically generated">
            <a:extLst>
              <a:ext uri="{FF2B5EF4-FFF2-40B4-BE49-F238E27FC236}">
                <a16:creationId xmlns:a16="http://schemas.microsoft.com/office/drawing/2014/main" id="{C8121F66-7AA7-504E-BF34-193FE12CB326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colorTemperature colorTemp="53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7837714" y="966520"/>
            <a:ext cx="4211881" cy="5192233"/>
          </a:xfrm>
          <a:prstGeom prst="rect">
            <a:avLst/>
          </a:prstGeom>
        </p:spPr>
      </p:pic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95998967-086A-9A45-91CB-95F664053612}"/>
              </a:ext>
            </a:extLst>
          </p:cNvPr>
          <p:cNvCxnSpPr/>
          <p:nvPr/>
        </p:nvCxnSpPr>
        <p:spPr>
          <a:xfrm>
            <a:off x="1835176" y="2131840"/>
            <a:ext cx="5780303" cy="0"/>
          </a:xfrm>
          <a:prstGeom prst="line">
            <a:avLst/>
          </a:prstGeom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EFF3FF36-BACA-174E-A32F-469F7EE5FB6C}"/>
              </a:ext>
            </a:extLst>
          </p:cNvPr>
          <p:cNvCxnSpPr>
            <a:cxnSpLocks/>
          </p:cNvCxnSpPr>
          <p:nvPr/>
        </p:nvCxnSpPr>
        <p:spPr>
          <a:xfrm>
            <a:off x="126124" y="2979184"/>
            <a:ext cx="7446683" cy="0"/>
          </a:xfrm>
          <a:prstGeom prst="line">
            <a:avLst/>
          </a:prstGeom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BD1260AC-2712-D04A-813C-D0AB7E7C55C4}"/>
              </a:ext>
            </a:extLst>
          </p:cNvPr>
          <p:cNvCxnSpPr>
            <a:cxnSpLocks/>
          </p:cNvCxnSpPr>
          <p:nvPr/>
        </p:nvCxnSpPr>
        <p:spPr>
          <a:xfrm>
            <a:off x="95644" y="5167648"/>
            <a:ext cx="7446683" cy="0"/>
          </a:xfrm>
          <a:prstGeom prst="line">
            <a:avLst/>
          </a:prstGeom>
        </p:spPr>
        <p:style>
          <a:lnRef idx="3">
            <a:schemeClr val="accent6"/>
          </a:lnRef>
          <a:fillRef idx="0">
            <a:schemeClr val="accent6"/>
          </a:fillRef>
          <a:effectRef idx="2">
            <a:schemeClr val="accent6"/>
          </a:effectRef>
          <a:fontRef idx="minor">
            <a:schemeClr val="tx1"/>
          </a:fontRef>
        </p:style>
      </p:cxnSp>
      <p:pic>
        <p:nvPicPr>
          <p:cNvPr id="20" name="Picture 19">
            <a:extLst>
              <a:ext uri="{FF2B5EF4-FFF2-40B4-BE49-F238E27FC236}">
                <a16:creationId xmlns:a16="http://schemas.microsoft.com/office/drawing/2014/main" id="{D5ABED92-649A-974A-863F-4945BDFA23B7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t="25941"/>
          <a:stretch/>
        </p:blipFill>
        <p:spPr>
          <a:xfrm>
            <a:off x="5453999" y="4971598"/>
            <a:ext cx="2092849" cy="1143999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BC82B56A-2722-544A-B09B-BAEE60074CAC}"/>
              </a:ext>
            </a:extLst>
          </p:cNvPr>
          <p:cNvSpPr txBox="1"/>
          <p:nvPr/>
        </p:nvSpPr>
        <p:spPr>
          <a:xfrm>
            <a:off x="59200" y="5127374"/>
            <a:ext cx="5333840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Conclusions</a:t>
            </a:r>
            <a:r>
              <a:rPr lang="en-US" sz="1600" dirty="0"/>
              <a:t>: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600" dirty="0"/>
              <a:t>By all measures, there was no significant change in measured viral load with home storage in a frost-free freezer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980512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CB32E07EFAD3E54C82B0ADD6F67780BC" ma:contentTypeVersion="12" ma:contentTypeDescription="Create a new document." ma:contentTypeScope="" ma:versionID="ae816242d01d668c2db721fa9edcdf46">
  <xsd:schema xmlns:xsd="http://www.w3.org/2001/XMLSchema" xmlns:xs="http://www.w3.org/2001/XMLSchema" xmlns:p="http://schemas.microsoft.com/office/2006/metadata/properties" xmlns:ns3="4748f3cc-a7b3-4f74-9c2f-91806ac88731" xmlns:ns4="a50305bf-f20c-45b5-95fe-0c3b9f2af3a3" targetNamespace="http://schemas.microsoft.com/office/2006/metadata/properties" ma:root="true" ma:fieldsID="8ca5950ea94b62bb1bf2a602428f57fa" ns3:_="" ns4:_="">
    <xsd:import namespace="4748f3cc-a7b3-4f74-9c2f-91806ac88731"/>
    <xsd:import namespace="a50305bf-f20c-45b5-95fe-0c3b9f2af3a3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Tags" minOccurs="0"/>
                <xsd:element ref="ns3:MediaServiceOCR" minOccurs="0"/>
                <xsd:element ref="ns3:MediaServiceDateTaken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748f3cc-a7b3-4f74-9c2f-91806ac8873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5" nillable="true" ma:displayName="MediaServiceDateTaken" ma:hidden="true" ma:internalName="MediaServiceDateTaken" ma:readOnly="true">
      <xsd:simpleType>
        <xsd:restriction base="dms:Text"/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8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9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50305bf-f20c-45b5-95fe-0c3b9f2af3a3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2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7E85C07C-ED92-468F-ADCD-68FCA18E72E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748f3cc-a7b3-4f74-9c2f-91806ac88731"/>
    <ds:schemaRef ds:uri="a50305bf-f20c-45b5-95fe-0c3b9f2af3a3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952490DB-A17C-4E96-B3C6-7A6120172BC3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A7FC2848-6B7E-4378-81B4-50ED554E686C}">
  <ds:schemaRefs>
    <ds:schemaRef ds:uri="http://purl.org/dc/dcmitype/"/>
    <ds:schemaRef ds:uri="http://schemas.openxmlformats.org/package/2006/metadata/core-properties"/>
    <ds:schemaRef ds:uri="4748f3cc-a7b3-4f74-9c2f-91806ac88731"/>
    <ds:schemaRef ds:uri="http://schemas.microsoft.com/office/2006/documentManagement/types"/>
    <ds:schemaRef ds:uri="http://purl.org/dc/terms/"/>
    <ds:schemaRef ds:uri="a50305bf-f20c-45b5-95fe-0c3b9f2af3a3"/>
    <ds:schemaRef ds:uri="http://schemas.microsoft.com/office/infopath/2007/PartnerControls"/>
    <ds:schemaRef ds:uri="http://schemas.microsoft.com/office/2006/metadata/properties"/>
    <ds:schemaRef ds:uri="http://www.w3.org/XML/1998/namespace"/>
    <ds:schemaRef ds:uri="http://purl.org/dc/elements/1.1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201</TotalTime>
  <Words>228</Words>
  <Application>Microsoft Office PowerPoint</Application>
  <PresentationFormat>Widescreen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 G Ison</dc:creator>
  <cp:lastModifiedBy>Karthikeyan, Roopini -</cp:lastModifiedBy>
  <cp:revision>14</cp:revision>
  <dcterms:created xsi:type="dcterms:W3CDTF">2021-10-22T20:34:26Z</dcterms:created>
  <dcterms:modified xsi:type="dcterms:W3CDTF">2022-02-14T17:55:1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B32E07EFAD3E54C82B0ADD6F67780BC</vt:lpwstr>
  </property>
</Properties>
</file>